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14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r>
              <a:rPr lang="en-US" sz="1400" dirty="0">
                <a:latin typeface="Calibri Light" panose="020F0302020204030204" pitchFamily="34" charset="0"/>
                <a:cs typeface="Calibri Light" panose="020F0302020204030204" pitchFamily="34" charset="0"/>
              </a:rPr>
              <a:t>FR/R</a:t>
            </a:r>
            <a:endParaRPr lang="zh-CN" sz="1400" dirty="0">
              <a:latin typeface="Calibri Light" panose="020F0302020204030204" pitchFamily="34" charset="0"/>
              <a:cs typeface="Calibri Light" panose="020F0302020204030204" pitchFamily="34" charset="0"/>
            </a:endParaRPr>
          </a:p>
        </c:rich>
      </c:tx>
      <c:layout>
        <c:manualLayout>
          <c:xMode val="edge"/>
          <c:yMode val="edge"/>
          <c:x val="0.49577777777777776"/>
          <c:y val="2.31481481481481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4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j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3911832895888013"/>
          <c:y val="0.12052092446777483"/>
          <c:w val="0.73310389326334213"/>
          <c:h val="0.6758509864410530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1:$G$26</c:f>
                <c:numCache>
                  <c:formatCode>General</c:formatCode>
                  <c:ptCount val="6"/>
                  <c:pt idx="0">
                    <c:v>0.10652152786122682</c:v>
                  </c:pt>
                  <c:pt idx="1">
                    <c:v>0.18986584021414332</c:v>
                  </c:pt>
                  <c:pt idx="2">
                    <c:v>0.68741531399637568</c:v>
                  </c:pt>
                  <c:pt idx="3">
                    <c:v>0.11576802164837741</c:v>
                  </c:pt>
                  <c:pt idx="4">
                    <c:v>0.25221518387534436</c:v>
                  </c:pt>
                  <c:pt idx="5">
                    <c:v>0.21834441013986972</c:v>
                  </c:pt>
                </c:numCache>
              </c:numRef>
            </c:plus>
            <c:minus>
              <c:numRef>
                <c:f>Sheet1!$G$21:$G$26</c:f>
                <c:numCache>
                  <c:formatCode>General</c:formatCode>
                  <c:ptCount val="6"/>
                  <c:pt idx="0">
                    <c:v>0.10652152786122682</c:v>
                  </c:pt>
                  <c:pt idx="1">
                    <c:v>0.18986584021414332</c:v>
                  </c:pt>
                  <c:pt idx="2">
                    <c:v>0.68741531399637568</c:v>
                  </c:pt>
                  <c:pt idx="3">
                    <c:v>0.11576802164837741</c:v>
                  </c:pt>
                  <c:pt idx="4">
                    <c:v>0.25221518387534436</c:v>
                  </c:pt>
                  <c:pt idx="5">
                    <c:v>0.2183444101398697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1:$D$26</c:f>
              <c:strCache>
                <c:ptCount val="6"/>
                <c:pt idx="0">
                  <c:v>0 h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  <c:pt idx="4">
                  <c:v>12 h</c:v>
                </c:pt>
                <c:pt idx="5">
                  <c:v>24 h</c:v>
                </c:pt>
              </c:strCache>
            </c:strRef>
          </c:cat>
          <c:val>
            <c:numRef>
              <c:f>Sheet1!$E$21:$E$26</c:f>
              <c:numCache>
                <c:formatCode>General</c:formatCode>
                <c:ptCount val="6"/>
                <c:pt idx="0">
                  <c:v>1</c:v>
                </c:pt>
                <c:pt idx="1">
                  <c:v>3.4962231251763685</c:v>
                </c:pt>
                <c:pt idx="2">
                  <c:v>3.9906427502677495</c:v>
                </c:pt>
                <c:pt idx="3">
                  <c:v>5.1382347780863178</c:v>
                </c:pt>
                <c:pt idx="4">
                  <c:v>2.0503541110939354</c:v>
                </c:pt>
                <c:pt idx="5">
                  <c:v>1.01930220663047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2345632"/>
        <c:axId val="1362349984"/>
      </c:barChart>
      <c:catAx>
        <c:axId val="13623456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/>
                  <a:t>Time after treatment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35523272090988628"/>
              <c:y val="0.9166666666666666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7030A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62349984"/>
        <c:crosses val="autoZero"/>
        <c:auto val="1"/>
        <c:lblAlgn val="ctr"/>
        <c:lblOffset val="100"/>
        <c:noMultiLvlLbl val="0"/>
      </c:catAx>
      <c:valAx>
        <c:axId val="13623499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dirty="0">
                    <a:latin typeface="Calibri Light" panose="020F0302020204030204" pitchFamily="34" charset="0"/>
                    <a:cs typeface="Calibri Light" panose="020F0302020204030204" pitchFamily="34" charset="0"/>
                  </a:rPr>
                  <a:t>Relative gene expression</a:t>
                </a:r>
                <a:endParaRPr lang="zh-CN" dirty="0">
                  <a:latin typeface="Calibri Light" panose="020F0302020204030204" pitchFamily="34" charset="0"/>
                  <a:cs typeface="Calibri Light" panose="020F0302020204030204" pitchFamily="34" charset="0"/>
                </a:endParaRPr>
              </a:p>
            </c:rich>
          </c:tx>
          <c:layout>
            <c:manualLayout>
              <c:xMode val="edge"/>
              <c:yMode val="edge"/>
              <c:x val="1.6097112860892389E-2"/>
              <c:y val="0.1540409011373578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62345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200">
          <a:latin typeface="+mj-lt"/>
        </a:defRPr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altLang="zh-CN" dirty="0">
                <a:latin typeface="Calibri Light" panose="020F0302020204030204" pitchFamily="34" charset="0"/>
                <a:cs typeface="Calibri Light" panose="020F0302020204030204" pitchFamily="34" charset="0"/>
              </a:rPr>
              <a:t>FR</a:t>
            </a:r>
            <a:endParaRPr lang="zh-CN" altLang="en-US" dirty="0">
              <a:latin typeface="Calibri Light" panose="020F0302020204030204" pitchFamily="34" charset="0"/>
              <a:cs typeface="Calibri Light" panose="020F0302020204030204" pitchFamily="34" charset="0"/>
            </a:endParaRPr>
          </a:p>
        </c:rich>
      </c:tx>
      <c:layout>
        <c:manualLayout>
          <c:xMode val="edge"/>
          <c:yMode val="edge"/>
          <c:x val="0.54717344706911641"/>
          <c:y val="6.018518518518518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0.12035870516185476"/>
          <c:y val="0.13004629629629633"/>
          <c:w val="0.80464129483814517"/>
          <c:h val="0.676718431029454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M$21:$M$26</c:f>
                <c:numCache>
                  <c:formatCode>General</c:formatCode>
                  <c:ptCount val="6"/>
                  <c:pt idx="0">
                    <c:v>0.20630696238638491</c:v>
                  </c:pt>
                  <c:pt idx="1">
                    <c:v>0.18986584021414332</c:v>
                  </c:pt>
                  <c:pt idx="2">
                    <c:v>8.4556291441846732E-2</c:v>
                  </c:pt>
                  <c:pt idx="3">
                    <c:v>3.4913944501741706E-2</c:v>
                  </c:pt>
                  <c:pt idx="4">
                    <c:v>4.0119539358915601E-2</c:v>
                  </c:pt>
                  <c:pt idx="5">
                    <c:v>2.7259891728987712E-2</c:v>
                  </c:pt>
                </c:numCache>
              </c:numRef>
            </c:plus>
            <c:minus>
              <c:numRef>
                <c:f>Sheet1!$M$21:$M$26</c:f>
                <c:numCache>
                  <c:formatCode>General</c:formatCode>
                  <c:ptCount val="6"/>
                  <c:pt idx="0">
                    <c:v>0.20630696238638491</c:v>
                  </c:pt>
                  <c:pt idx="1">
                    <c:v>0.18986584021414332</c:v>
                  </c:pt>
                  <c:pt idx="2">
                    <c:v>8.4556291441846732E-2</c:v>
                  </c:pt>
                  <c:pt idx="3">
                    <c:v>3.4913944501741706E-2</c:v>
                  </c:pt>
                  <c:pt idx="4">
                    <c:v>4.0119539358915601E-2</c:v>
                  </c:pt>
                  <c:pt idx="5">
                    <c:v>2.725989172898771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J$21:$J$26</c:f>
              <c:strCache>
                <c:ptCount val="6"/>
                <c:pt idx="0">
                  <c:v>0 h</c:v>
                </c:pt>
                <c:pt idx="1">
                  <c:v>1 h</c:v>
                </c:pt>
                <c:pt idx="2">
                  <c:v>3 h</c:v>
                </c:pt>
                <c:pt idx="3">
                  <c:v>6 h</c:v>
                </c:pt>
                <c:pt idx="4">
                  <c:v>12 h</c:v>
                </c:pt>
                <c:pt idx="5">
                  <c:v>24 h</c:v>
                </c:pt>
              </c:strCache>
            </c:strRef>
          </c:cat>
          <c:val>
            <c:numRef>
              <c:f>Sheet1!$K$21:$K$26</c:f>
              <c:numCache>
                <c:formatCode>General</c:formatCode>
                <c:ptCount val="6"/>
                <c:pt idx="0">
                  <c:v>1</c:v>
                </c:pt>
                <c:pt idx="1">
                  <c:v>3.4962231251763685</c:v>
                </c:pt>
                <c:pt idx="2">
                  <c:v>0.85757019480030749</c:v>
                </c:pt>
                <c:pt idx="3">
                  <c:v>0.24815087429175997</c:v>
                </c:pt>
                <c:pt idx="4">
                  <c:v>0.42888469182294509</c:v>
                </c:pt>
                <c:pt idx="5">
                  <c:v>0.176438215620529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2346176"/>
        <c:axId val="1362352704"/>
      </c:barChart>
      <c:catAx>
        <c:axId val="1362346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altLang="zh-CN" sz="1200" b="0" i="0" baseline="0" dirty="0">
                    <a:effectLst/>
                    <a:latin typeface="+mj-lt"/>
                  </a:rPr>
                  <a:t>Time after treatment</a:t>
                </a:r>
                <a:endParaRPr lang="zh-CN" altLang="zh-CN" sz="1200" dirty="0">
                  <a:effectLst/>
                  <a:latin typeface="+mj-lt"/>
                </a:endParaRPr>
              </a:p>
            </c:rich>
          </c:tx>
          <c:layout>
            <c:manualLayout>
              <c:xMode val="edge"/>
              <c:yMode val="edge"/>
              <c:x val="0.3730194663167104"/>
              <c:y val="0.915283064078894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7030A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62352704"/>
        <c:crosses val="autoZero"/>
        <c:auto val="1"/>
        <c:lblAlgn val="ctr"/>
        <c:lblOffset val="0"/>
        <c:noMultiLvlLbl val="0"/>
      </c:catAx>
      <c:valAx>
        <c:axId val="1362352704"/>
        <c:scaling>
          <c:orientation val="minMax"/>
          <c:max val="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j-lt"/>
                    <a:ea typeface="+mn-ea"/>
                    <a:cs typeface="+mn-cs"/>
                  </a:defRPr>
                </a:pPr>
                <a:r>
                  <a:rPr lang="en-US" altLang="zh-CN" sz="1200" b="0" i="0" baseline="0">
                    <a:effectLst/>
                    <a:latin typeface="+mj-lt"/>
                  </a:rPr>
                  <a:t>Relative gene expression</a:t>
                </a:r>
                <a:endParaRPr lang="zh-CN" altLang="zh-CN" sz="1200">
                  <a:effectLst/>
                  <a:latin typeface="+mj-lt"/>
                </a:endParaRPr>
              </a:p>
            </c:rich>
          </c:tx>
          <c:layout>
            <c:manualLayout>
              <c:xMode val="edge"/>
              <c:yMode val="edge"/>
              <c:x val="5.5555555555555558E-3"/>
              <c:y val="0.1439351851851851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j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j-lt"/>
                <a:ea typeface="+mn-ea"/>
                <a:cs typeface="+mn-cs"/>
              </a:defRPr>
            </a:pPr>
            <a:endParaRPr lang="zh-CN"/>
          </a:p>
        </c:txPr>
        <c:crossAx val="13623461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8315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5997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1279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8534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1778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8071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8614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5756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4019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076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7862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AA7332-03FE-4B32-8749-2ECE1114C95D}" type="datetimeFigureOut">
              <a:rPr lang="zh-CN" altLang="en-US" smtClean="0"/>
              <a:t>2022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D81CC0-8779-403D-BE75-AACDB10FD4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1508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490867" y="66255"/>
            <a:ext cx="10734261" cy="6723260"/>
            <a:chOff x="490867" y="66255"/>
            <a:chExt cx="10734261" cy="6723260"/>
          </a:xfrm>
        </p:grpSpPr>
        <p:cxnSp>
          <p:nvCxnSpPr>
            <p:cNvPr id="6" name="直接连接符 5"/>
            <p:cNvCxnSpPr/>
            <p:nvPr/>
          </p:nvCxnSpPr>
          <p:spPr>
            <a:xfrm>
              <a:off x="5995293" y="542229"/>
              <a:ext cx="0" cy="19260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490867" y="5404520"/>
              <a:ext cx="10734261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>
                <a:lnSpc>
                  <a:spcPct val="150000"/>
                </a:lnSpc>
              </a:pP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.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expression pattern of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fter FR/R and FR treatments. (A) qRT-PCR analysis of </a:t>
              </a:r>
              <a:r>
                <a:rPr lang="en-US" altLang="zh-CN" sz="14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 under FR/R treatment. (B)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qRT-PCR analysis of </a:t>
              </a:r>
              <a:r>
                <a:rPr lang="en-US" altLang="zh-CN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F6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 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 FR </a:t>
              </a:r>
              <a:r>
                <a:rPr lang="en-US" altLang="zh-CN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eatment. Note</a:t>
              </a:r>
              <a:r>
                <a:rPr lang="en-US" altLang="zh-CN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0 h indicates time point before seed imbibition; 1 h indicates the time point after imbibition for 1 h under white light; 3 to 24 h indicate the time points after FR/R or FR treatment. </a:t>
              </a:r>
              <a:r>
                <a:rPr lang="en-US" altLang="zh-CN" sz="1400" i="1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2A </a:t>
              </a:r>
              <a:r>
                <a:rPr lang="en-US" altLang="zh-CN" sz="1400" kern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 used as an internal control. Values are shown as means ± </a:t>
              </a:r>
              <a:r>
                <a:rPr lang="en-US" altLang="zh-CN" sz="1400" kern="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.</a:t>
              </a:r>
              <a:endPara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3331324" y="66255"/>
              <a:ext cx="33374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 smtClean="0"/>
                <a:t>A</a:t>
              </a:r>
              <a:endParaRPr lang="zh-CN" altLang="en-US" sz="2000" dirty="0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3331324" y="2718586"/>
              <a:ext cx="3241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 smtClean="0"/>
                <a:t>B</a:t>
              </a:r>
              <a:endParaRPr lang="zh-CN" altLang="en-US" sz="2000" dirty="0"/>
            </a:p>
          </p:txBody>
        </p:sp>
        <p:graphicFrame>
          <p:nvGraphicFramePr>
            <p:cNvPr id="14" name="图表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50302184"/>
                </p:ext>
              </p:extLst>
            </p:nvPr>
          </p:nvGraphicFramePr>
          <p:xfrm>
            <a:off x="3693924" y="184963"/>
            <a:ext cx="4572000" cy="25582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图表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53359601"/>
                </p:ext>
              </p:extLst>
            </p:nvPr>
          </p:nvGraphicFramePr>
          <p:xfrm>
            <a:off x="3693924" y="2825495"/>
            <a:ext cx="4572000" cy="25582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63230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111</Words>
  <Application>Microsoft Office PowerPoint</Application>
  <PresentationFormat>宽屏</PresentationFormat>
  <Paragraphs>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10</cp:revision>
  <dcterms:created xsi:type="dcterms:W3CDTF">2022-12-14T01:46:35Z</dcterms:created>
  <dcterms:modified xsi:type="dcterms:W3CDTF">2022-12-15T09:14:21Z</dcterms:modified>
</cp:coreProperties>
</file>